
<file path=[Content_Types].xml><?xml version="1.0" encoding="utf-8"?>
<Types xmlns="http://schemas.openxmlformats.org/package/2006/content-types"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64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3.xml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56865" y="8832583"/>
            <a:ext cx="60832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600" dirty="0" smtClean="0"/>
              <a:t>Figure 4D, The lines shown in the figure 4D are indicated with red boxes</a:t>
            </a:r>
            <a:endParaRPr lang="zh-CN" altLang="en-US" sz="1600" dirty="0"/>
          </a:p>
        </p:txBody>
      </p:sp>
      <p:pic>
        <p:nvPicPr>
          <p:cNvPr id="16" name="图片 15"/>
          <p:cNvPicPr/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44" t="38038" r="9438" b="41163"/>
          <a:stretch>
            <a:fillRect/>
          </a:stretch>
        </p:blipFill>
        <p:spPr bwMode="auto">
          <a:xfrm>
            <a:off x="490679" y="9295500"/>
            <a:ext cx="3054350" cy="605155"/>
          </a:xfrm>
          <a:prstGeom prst="rect">
            <a:avLst/>
          </a:prstGeom>
          <a:ln>
            <a:noFill/>
          </a:ln>
        </p:spPr>
      </p:pic>
      <p:pic>
        <p:nvPicPr>
          <p:cNvPr id="42" name="图片 4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43" t="40690" r="13719" b="36532"/>
          <a:stretch>
            <a:fillRect/>
          </a:stretch>
        </p:blipFill>
        <p:spPr bwMode="auto">
          <a:xfrm>
            <a:off x="3679996" y="9351270"/>
            <a:ext cx="2845435" cy="673100"/>
          </a:xfrm>
          <a:prstGeom prst="rect">
            <a:avLst/>
          </a:prstGeom>
          <a:ln>
            <a:noFill/>
          </a:ln>
        </p:spPr>
      </p:pic>
      <p:sp>
        <p:nvSpPr>
          <p:cNvPr id="45" name="文本框 44"/>
          <p:cNvSpPr txBox="1"/>
          <p:nvPr/>
        </p:nvSpPr>
        <p:spPr>
          <a:xfrm>
            <a:off x="1617486" y="9171137"/>
            <a:ext cx="8274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 dirty="0" smtClean="0"/>
              <a:t>Anti-NS1</a:t>
            </a:r>
            <a:endParaRPr lang="zh-CN" altLang="en-US" sz="1400" dirty="0"/>
          </a:p>
        </p:txBody>
      </p:sp>
      <p:sp>
        <p:nvSpPr>
          <p:cNvPr id="46" name="文本框 45"/>
          <p:cNvSpPr txBox="1"/>
          <p:nvPr/>
        </p:nvSpPr>
        <p:spPr>
          <a:xfrm>
            <a:off x="4653241" y="9084515"/>
            <a:ext cx="10726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 dirty="0" smtClean="0"/>
              <a:t>Anti-GAPDH</a:t>
            </a:r>
            <a:endParaRPr lang="zh-CN" altLang="en-US" sz="1400" dirty="0"/>
          </a:p>
        </p:txBody>
      </p:sp>
      <p:sp>
        <p:nvSpPr>
          <p:cNvPr id="54" name="矩形 53"/>
          <p:cNvSpPr/>
          <p:nvPr/>
        </p:nvSpPr>
        <p:spPr>
          <a:xfrm>
            <a:off x="2412648" y="9480244"/>
            <a:ext cx="898702" cy="37261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56" name="矩形 55"/>
          <p:cNvSpPr/>
          <p:nvPr/>
        </p:nvSpPr>
        <p:spPr>
          <a:xfrm>
            <a:off x="5535272" y="9423069"/>
            <a:ext cx="898702" cy="37261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6" name="图片 5"/>
          <p:cNvPicPr/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44" t="38038" r="9438" b="41163"/>
          <a:stretch>
            <a:fillRect/>
          </a:stretch>
        </p:blipFill>
        <p:spPr bwMode="auto">
          <a:xfrm>
            <a:off x="617679" y="9422500"/>
            <a:ext cx="3054350" cy="605155"/>
          </a:xfrm>
          <a:prstGeom prst="rect">
            <a:avLst/>
          </a:prstGeom>
          <a:ln>
            <a:noFill/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8200" y="2214880"/>
            <a:ext cx="3055620" cy="6096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9955" y="3020695"/>
            <a:ext cx="2849880" cy="678180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5329555" y="2418080"/>
            <a:ext cx="848995" cy="31813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5329555" y="3112770"/>
            <a:ext cx="848995" cy="318135"/>
          </a:xfrm>
          <a:prstGeom prst="rect">
            <a:avLst/>
          </a:prstGeom>
          <a:noFill/>
          <a:ln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6330950" y="2418080"/>
            <a:ext cx="857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pl-PL" altLang="zh-CN"/>
              <a:t>NS1</a:t>
            </a:r>
            <a:endParaRPr lang="pl-PL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6398260" y="3062605"/>
            <a:ext cx="1069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pl-PL" altLang="zh-CN"/>
              <a:t>GAPDH</a:t>
            </a:r>
            <a:endParaRPr lang="pl-PL" altLang="zh-CN"/>
          </a:p>
        </p:txBody>
      </p:sp>
      <p:sp>
        <p:nvSpPr>
          <p:cNvPr id="13" name="文本框 12"/>
          <p:cNvSpPr txBox="1"/>
          <p:nvPr/>
        </p:nvSpPr>
        <p:spPr>
          <a:xfrm rot="19320000">
            <a:off x="5527675" y="1685925"/>
            <a:ext cx="12865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pl-PL" altLang="zh-CN" sz="1400"/>
              <a:t>HC-070</a:t>
            </a:r>
            <a:endParaRPr lang="pl-PL" altLang="zh-CN" sz="1400"/>
          </a:p>
        </p:txBody>
      </p:sp>
      <p:sp>
        <p:nvSpPr>
          <p:cNvPr id="14" name="文本框 13"/>
          <p:cNvSpPr txBox="1"/>
          <p:nvPr/>
        </p:nvSpPr>
        <p:spPr>
          <a:xfrm rot="19320000">
            <a:off x="5839460" y="1747520"/>
            <a:ext cx="128651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pl-PL" altLang="zh-CN" sz="1400"/>
              <a:t>AC1903</a:t>
            </a:r>
            <a:endParaRPr lang="pl-PL" altLang="zh-CN" sz="1400"/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COMMONDATA" val="eyJoZGlkIjoiY2E4ZGY1ZDc1YTIxZjBhYjhlODFjYjIzYzNkMjVhMDQ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WPS 演示</Application>
  <PresentationFormat>宽屏</PresentationFormat>
  <Paragraphs>14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陈兴娟</cp:lastModifiedBy>
  <cp:revision>155</cp:revision>
  <dcterms:created xsi:type="dcterms:W3CDTF">2019-06-19T02:08:00Z</dcterms:created>
  <dcterms:modified xsi:type="dcterms:W3CDTF">2024-02-12T13:35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763</vt:lpwstr>
  </property>
  <property fmtid="{D5CDD505-2E9C-101B-9397-08002B2CF9AE}" pid="3" name="ICV">
    <vt:lpwstr>1474302EC36E44BD881EEE4E2D93E973</vt:lpwstr>
  </property>
</Properties>
</file>